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84" autoAdjust="0"/>
    <p:restoredTop sz="94660"/>
  </p:normalViewPr>
  <p:slideViewPr>
    <p:cSldViewPr snapToGrid="0" showGuides="1">
      <p:cViewPr varScale="1">
        <p:scale>
          <a:sx n="124" d="100"/>
          <a:sy n="124" d="100"/>
        </p:scale>
        <p:origin x="584" y="1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.bin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7.bin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35910192358182291"/>
          <c:y val="7.40740740740740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QA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'[Chart in Microsoft PowerPoint]Sheet5'!$O$5</c:f>
              <c:strCache>
                <c:ptCount val="1"/>
                <c:pt idx="0">
                  <c:v>Enterovirus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explosion val="15"/>
          <c:dPt>
            <c:idx val="0"/>
            <c:bubble3D val="0"/>
            <c:spPr>
              <a:solidFill>
                <a:srgbClr val="FB15AE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306-4717-92C9-0C13869DEC6C}"/>
              </c:ext>
            </c:extLst>
          </c:dPt>
          <c:dPt>
            <c:idx val="1"/>
            <c:bubble3D val="0"/>
            <c:spPr>
              <a:solidFill>
                <a:srgbClr val="FD8DD8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8306-4717-92C9-0C13869DEC6C}"/>
              </c:ext>
            </c:extLst>
          </c:dPt>
          <c:dPt>
            <c:idx val="2"/>
            <c:bubble3D val="0"/>
            <c:spPr>
              <a:solidFill>
                <a:srgbClr val="FFCCFF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8306-4717-92C9-0C13869DEC6C}"/>
              </c:ext>
            </c:extLst>
          </c:dPt>
          <c:dPt>
            <c:idx val="3"/>
            <c:bubble3D val="0"/>
            <c:spPr>
              <a:solidFill>
                <a:srgbClr val="FFCCFF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8306-4717-92C9-0C13869DEC6C}"/>
              </c:ext>
            </c:extLst>
          </c:dPt>
          <c:dLbls>
            <c:dLbl>
              <c:idx val="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8306-4717-92C9-0C13869DEC6C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QA"/>
              </a:p>
            </c:txPr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[Chart in Microsoft PowerPoint]Sheet5'!$M$6:$M$9</c:f>
              <c:strCache>
                <c:ptCount val="4"/>
                <c:pt idx="0">
                  <c:v>Children (&lt; 1-9 years)</c:v>
                </c:pt>
                <c:pt idx="1">
                  <c:v>Adolscence (10-17)</c:v>
                </c:pt>
                <c:pt idx="2">
                  <c:v>Adult (18-59)</c:v>
                </c:pt>
                <c:pt idx="3">
                  <c:v>Seniors  (&gt; 60 years)</c:v>
                </c:pt>
              </c:strCache>
            </c:strRef>
          </c:cat>
          <c:val>
            <c:numRef>
              <c:f>'[Chart in Microsoft PowerPoint]Sheet5'!$O$6:$O$9</c:f>
              <c:numCache>
                <c:formatCode>0%</c:formatCode>
                <c:ptCount val="4"/>
                <c:pt idx="0">
                  <c:v>0.85089463220675943</c:v>
                </c:pt>
                <c:pt idx="1">
                  <c:v>8.9463220675944338E-2</c:v>
                </c:pt>
                <c:pt idx="2">
                  <c:v>5.7654075546719682E-2</c:v>
                </c:pt>
                <c:pt idx="3">
                  <c:v>1.9880715705765406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8306-4717-92C9-0C13869DEC6C}"/>
            </c:ext>
          </c:extLst>
        </c:ser>
        <c:dLbls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 w="25400">
          <a:noFill/>
        </a:ln>
        <a:effectLst/>
      </c:spPr>
    </c:plotArea>
    <c:legend>
      <c:legendPos val="r"/>
      <c:layout>
        <c:manualLayout>
          <c:xMode val="edge"/>
          <c:yMode val="edge"/>
          <c:x val="0.57757830271216093"/>
          <c:y val="0.39951261300670748"/>
          <c:w val="0.2856731579921446"/>
          <c:h val="0.3125021872265967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QA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QA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324590113735783"/>
          <c:y val="7.40740740740740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QA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'[Chart in Microsoft PowerPoint]Sheet8'!$F$4</c:f>
              <c:strCache>
                <c:ptCount val="1"/>
                <c:pt idx="0">
                  <c:v>Epstein-Barr virus 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explosion val="7"/>
          <c:dPt>
            <c:idx val="0"/>
            <c:bubble3D val="0"/>
            <c:spPr>
              <a:solidFill>
                <a:srgbClr val="FFFF99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BDE2-4385-86B0-946E5BD9B167}"/>
              </c:ext>
            </c:extLst>
          </c:dPt>
          <c:dPt>
            <c:idx val="1"/>
            <c:bubble3D val="0"/>
            <c:spPr>
              <a:solidFill>
                <a:srgbClr val="FFFFCC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BDE2-4385-86B0-946E5BD9B167}"/>
              </c:ext>
            </c:extLst>
          </c:dPt>
          <c:dPt>
            <c:idx val="2"/>
            <c:bubble3D val="0"/>
            <c:spPr>
              <a:solidFill>
                <a:srgbClr val="FFFF00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BDE2-4385-86B0-946E5BD9B167}"/>
              </c:ext>
            </c:extLst>
          </c:dPt>
          <c:dPt>
            <c:idx val="3"/>
            <c:bubble3D val="0"/>
            <c:spPr>
              <a:solidFill>
                <a:srgbClr val="FFFFFF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BDE2-4385-86B0-946E5BD9B167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QA"/>
              </a:p>
            </c:txPr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[Chart in Microsoft PowerPoint]Sheet8'!$D$5:$D$8</c:f>
              <c:strCache>
                <c:ptCount val="4"/>
                <c:pt idx="0">
                  <c:v>Children (&lt; 1-9 years)</c:v>
                </c:pt>
                <c:pt idx="1">
                  <c:v>Adolscence (10-17)</c:v>
                </c:pt>
                <c:pt idx="2">
                  <c:v>Adult (18-59)</c:v>
                </c:pt>
                <c:pt idx="3">
                  <c:v>Seniors  (&gt; 60 years)</c:v>
                </c:pt>
              </c:strCache>
            </c:strRef>
          </c:cat>
          <c:val>
            <c:numRef>
              <c:f>'[Chart in Microsoft PowerPoint]Sheet8'!$F$5:$F$8</c:f>
              <c:numCache>
                <c:formatCode>0%</c:formatCode>
                <c:ptCount val="4"/>
                <c:pt idx="0">
                  <c:v>0.17073170731707318</c:v>
                </c:pt>
                <c:pt idx="1">
                  <c:v>0.14634146341463414</c:v>
                </c:pt>
                <c:pt idx="2">
                  <c:v>0.56097560975609762</c:v>
                </c:pt>
                <c:pt idx="3">
                  <c:v>0.121951219512195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BDE2-4385-86B0-946E5BD9B167}"/>
            </c:ext>
          </c:extLst>
        </c:ser>
        <c:dLbls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59980052493438318"/>
          <c:y val="0.39488298337707789"/>
          <c:w val="0.28088756475490118"/>
          <c:h val="0.3125021872265967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QA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QA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QA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'[Chart in Microsoft PowerPoint]Sheet8'!$E$16</c:f>
              <c:strCache>
                <c:ptCount val="1"/>
                <c:pt idx="0">
                  <c:v>Adenovirus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explosion val="11"/>
          <c:dPt>
            <c:idx val="0"/>
            <c:bubble3D val="0"/>
            <c:spPr>
              <a:solidFill>
                <a:srgbClr val="FF0000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31CE-41AA-8321-2077EF22571E}"/>
              </c:ext>
            </c:extLst>
          </c:dPt>
          <c:dPt>
            <c:idx val="1"/>
            <c:bubble3D val="0"/>
            <c:spPr>
              <a:solidFill>
                <a:srgbClr val="FFCCCC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31CE-41AA-8321-2077EF22571E}"/>
              </c:ext>
            </c:extLst>
          </c:dPt>
          <c:dPt>
            <c:idx val="2"/>
            <c:bubble3D val="0"/>
            <c:spPr>
              <a:solidFill>
                <a:srgbClr val="FF7C80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31CE-41AA-8321-2077EF22571E}"/>
              </c:ext>
            </c:extLst>
          </c:dPt>
          <c:dPt>
            <c:idx val="3"/>
            <c:bubble3D val="0"/>
            <c:spPr>
              <a:solidFill>
                <a:srgbClr val="FFFFFF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31CE-41AA-8321-2077EF22571E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QA"/>
              </a:p>
            </c:txPr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[Chart in Microsoft PowerPoint]Sheet8'!$D$17:$D$20</c:f>
              <c:strCache>
                <c:ptCount val="4"/>
                <c:pt idx="0">
                  <c:v>Children (&lt; 1-9 years)</c:v>
                </c:pt>
                <c:pt idx="1">
                  <c:v>Adolscence (10-17)</c:v>
                </c:pt>
                <c:pt idx="2">
                  <c:v>Adult (18-59)</c:v>
                </c:pt>
                <c:pt idx="3">
                  <c:v>Seniors  (&gt; 60 years)</c:v>
                </c:pt>
              </c:strCache>
            </c:strRef>
          </c:cat>
          <c:val>
            <c:numRef>
              <c:f>'[Chart in Microsoft PowerPoint]Sheet8'!$E$17:$E$20</c:f>
              <c:numCache>
                <c:formatCode>General</c:formatCode>
                <c:ptCount val="4"/>
                <c:pt idx="0">
                  <c:v>33</c:v>
                </c:pt>
                <c:pt idx="1">
                  <c:v>3</c:v>
                </c:pt>
                <c:pt idx="2">
                  <c:v>10</c:v>
                </c:pt>
                <c:pt idx="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31CE-41AA-8321-2077EF22571E}"/>
            </c:ext>
          </c:extLst>
        </c:ser>
        <c:ser>
          <c:idx val="1"/>
          <c:order val="1"/>
          <c:tx>
            <c:strRef>
              <c:f>'[Chart in Microsoft PowerPoint]Sheet8'!$F$16</c:f>
              <c:strCache>
                <c:ptCount val="1"/>
                <c:pt idx="0">
                  <c:v>Adenovirus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A-31CE-41AA-8321-2077EF22571E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C-31CE-41AA-8321-2077EF22571E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E-31CE-41AA-8321-2077EF22571E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0-31CE-41AA-8321-2077EF22571E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QA"/>
              </a:p>
            </c:txPr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[Chart in Microsoft PowerPoint]Sheet8'!$D$17:$D$20</c:f>
              <c:strCache>
                <c:ptCount val="4"/>
                <c:pt idx="0">
                  <c:v>Children (&lt; 1-9 years)</c:v>
                </c:pt>
                <c:pt idx="1">
                  <c:v>Adolscence (10-17)</c:v>
                </c:pt>
                <c:pt idx="2">
                  <c:v>Adult (18-59)</c:v>
                </c:pt>
                <c:pt idx="3">
                  <c:v>Seniors  (&gt; 60 years)</c:v>
                </c:pt>
              </c:strCache>
            </c:strRef>
          </c:cat>
          <c:val>
            <c:numRef>
              <c:f>'[Chart in Microsoft PowerPoint]Sheet8'!$F$17:$F$20</c:f>
              <c:numCache>
                <c:formatCode>0%</c:formatCode>
                <c:ptCount val="4"/>
                <c:pt idx="0">
                  <c:v>0.7021276595744681</c:v>
                </c:pt>
                <c:pt idx="1">
                  <c:v>6.3829787234042548E-2</c:v>
                </c:pt>
                <c:pt idx="2">
                  <c:v>0.21276595744680851</c:v>
                </c:pt>
                <c:pt idx="3">
                  <c:v>2.127659574468085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1-31CE-41AA-8321-2077EF22571E}"/>
            </c:ext>
          </c:extLst>
        </c:ser>
        <c:dLbls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57757830271216093"/>
          <c:y val="0.40414224263633713"/>
          <c:w val="0.26131058617672792"/>
          <c:h val="0.3125021872265967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QA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QA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QA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Sheet6!$L$5</c:f>
              <c:strCache>
                <c:ptCount val="1"/>
                <c:pt idx="0">
                  <c:v>Herpes Simplex Virus type 1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explosion val="8"/>
          <c:dPt>
            <c:idx val="0"/>
            <c:bubble3D val="0"/>
            <c:spPr>
              <a:solidFill>
                <a:srgbClr val="C15A31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F57-458E-ABF8-1FF567452436}"/>
              </c:ext>
            </c:extLst>
          </c:dPt>
          <c:dPt>
            <c:idx val="1"/>
            <c:bubble3D val="0"/>
            <c:spPr>
              <a:solidFill>
                <a:srgbClr val="F4B184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AF57-458E-ABF8-1FF567452436}"/>
              </c:ext>
            </c:extLst>
          </c:dPt>
          <c:dPt>
            <c:idx val="2"/>
            <c:bubble3D val="0"/>
            <c:spPr>
              <a:solidFill>
                <a:srgbClr val="F19B61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AF57-458E-ABF8-1FF567452436}"/>
              </c:ext>
            </c:extLst>
          </c:dPt>
          <c:dPt>
            <c:idx val="3"/>
            <c:bubble3D val="0"/>
            <c:spPr>
              <a:solidFill>
                <a:schemeClr val="accent2">
                  <a:lumMod val="20000"/>
                  <a:lumOff val="8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AF57-458E-ABF8-1FF567452436}"/>
              </c:ext>
            </c:extLst>
          </c:dPt>
          <c:dLbls>
            <c:dLbl>
              <c:idx val="0"/>
              <c:tx>
                <c:rich>
                  <a:bodyPr/>
                  <a:lstStyle/>
                  <a:p>
                    <a:r>
                      <a:rPr lang="en-US"/>
                      <a:t>29%</a:t>
                    </a:r>
                    <a:endParaRPr lang="en-US" dirty="0"/>
                  </a:p>
                </c:rich>
              </c:tx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1-AF57-458E-ABF8-1FF567452436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r>
                      <a:rPr lang="en-US"/>
                      <a:t>7%</a:t>
                    </a:r>
                    <a:endParaRPr lang="en-US" dirty="0"/>
                  </a:p>
                </c:rich>
              </c:tx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3-AF57-458E-ABF8-1FF567452436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fld id="{DD7D32C0-84A9-4913-89C9-0B38055EFAF0}" type="VALUE">
                      <a:rPr lang="en-US" smtClean="0"/>
                      <a:pPr/>
                      <a:t>[VALUE]</a:t>
                    </a:fld>
                    <a:endParaRPr lang="en-QA"/>
                  </a:p>
                </c:rich>
              </c:tx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5-AF57-458E-ABF8-1FF567452436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r>
                      <a:rPr lang="en-US"/>
                      <a:t>7%</a:t>
                    </a:r>
                    <a:endParaRPr lang="en-US" dirty="0"/>
                  </a:p>
                </c:rich>
              </c:tx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7-AF57-458E-ABF8-1FF567452436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QA"/>
              </a:p>
            </c:txPr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Sheet6!$J$6:$J$9</c:f>
              <c:strCache>
                <c:ptCount val="4"/>
                <c:pt idx="0">
                  <c:v>Children (&lt; 1-9 years)</c:v>
                </c:pt>
                <c:pt idx="1">
                  <c:v>Adolscence (10-17)</c:v>
                </c:pt>
                <c:pt idx="2">
                  <c:v>Adult (18-59)</c:v>
                </c:pt>
                <c:pt idx="3">
                  <c:v>Seniors  (&gt; 60 years)</c:v>
                </c:pt>
              </c:strCache>
            </c:strRef>
          </c:cat>
          <c:val>
            <c:numRef>
              <c:f>Sheet6!$L$6:$L$9</c:f>
              <c:numCache>
                <c:formatCode>0%</c:formatCode>
                <c:ptCount val="4"/>
                <c:pt idx="0">
                  <c:v>0.2857142857142857</c:v>
                </c:pt>
                <c:pt idx="1">
                  <c:v>7.1428571428571425E-2</c:v>
                </c:pt>
                <c:pt idx="2">
                  <c:v>0.42857142857142855</c:v>
                </c:pt>
                <c:pt idx="3">
                  <c:v>7.142857142857142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AF57-458E-ABF8-1FF567452436}"/>
            </c:ext>
          </c:extLst>
        </c:ser>
        <c:dLbls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0535608048993872"/>
          <c:y val="0.40877187226596673"/>
          <c:w val="0.30211577540837187"/>
          <c:h val="0.3125021872265967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QA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QA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>
                <a:solidFill>
                  <a:schemeClr val="tx1"/>
                </a:solidFill>
              </a:rPr>
              <a:t>Herpes Simplex Virus type 2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QA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Sheet6!$H$5</c:f>
              <c:strCache>
                <c:ptCount val="1"/>
                <c:pt idx="0">
                  <c:v>Herpes Simplex Virus type 2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explosion val="10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F8AE-4FED-B225-18A4DA5A66AF}"/>
              </c:ext>
            </c:extLst>
          </c:dPt>
          <c:dPt>
            <c:idx val="1"/>
            <c:bubble3D val="0"/>
            <c:spPr>
              <a:solidFill>
                <a:schemeClr val="accent1">
                  <a:lumMod val="7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F8AE-4FED-B225-18A4DA5A66AF}"/>
              </c:ext>
            </c:extLst>
          </c:dPt>
          <c:dPt>
            <c:idx val="2"/>
            <c:bubble3D val="0"/>
            <c:spPr>
              <a:solidFill>
                <a:schemeClr val="accent1">
                  <a:lumMod val="5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F8AE-4FED-B225-18A4DA5A66AF}"/>
              </c:ext>
            </c:extLst>
          </c:dPt>
          <c:dPt>
            <c:idx val="3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F8AE-4FED-B225-18A4DA5A66AF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QA"/>
              </a:p>
            </c:txPr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Sheet6!$F$6:$F$9</c:f>
              <c:strCache>
                <c:ptCount val="4"/>
                <c:pt idx="0">
                  <c:v>Children (&lt; 1-9 years)</c:v>
                </c:pt>
                <c:pt idx="1">
                  <c:v>Adolscence (10-17)</c:v>
                </c:pt>
                <c:pt idx="2">
                  <c:v>Adult (18-59)</c:v>
                </c:pt>
                <c:pt idx="3">
                  <c:v>Seniors  (&gt; 60 years)</c:v>
                </c:pt>
              </c:strCache>
            </c:strRef>
          </c:cat>
          <c:val>
            <c:numRef>
              <c:f>Sheet6!$H$6:$H$9</c:f>
              <c:numCache>
                <c:formatCode>0%</c:formatCode>
                <c:ptCount val="4"/>
                <c:pt idx="0">
                  <c:v>0.14285714285714285</c:v>
                </c:pt>
                <c:pt idx="1">
                  <c:v>0</c:v>
                </c:pt>
                <c:pt idx="2">
                  <c:v>0.8571428571428571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F8AE-4FED-B225-18A4DA5A66AF}"/>
            </c:ext>
          </c:extLst>
        </c:ser>
        <c:dLbls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0257830271216095"/>
          <c:y val="0.41803113152522603"/>
          <c:w val="0.26131058617672792"/>
          <c:h val="0.3125021872265967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QA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QA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QA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Sheet6!$H$15</c:f>
              <c:strCache>
                <c:ptCount val="1"/>
                <c:pt idx="0">
                  <c:v>Cytomegalovirus 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explosion val="14"/>
          <c:dPt>
            <c:idx val="0"/>
            <c:bubble3D val="0"/>
            <c:spPr>
              <a:solidFill>
                <a:schemeClr val="accent6">
                  <a:lumMod val="7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6D5-4CDE-98C3-69CE473A239C}"/>
              </c:ext>
            </c:extLst>
          </c:dPt>
          <c:dPt>
            <c:idx val="1"/>
            <c:bubble3D val="0"/>
            <c:spPr>
              <a:solidFill>
                <a:schemeClr val="accent6">
                  <a:lumMod val="40000"/>
                  <a:lumOff val="6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A6D5-4CDE-98C3-69CE473A239C}"/>
              </c:ext>
            </c:extLst>
          </c:dPt>
          <c:dPt>
            <c:idx val="2"/>
            <c:bubble3D val="0"/>
            <c:spPr>
              <a:solidFill>
                <a:schemeClr val="accent6">
                  <a:lumMod val="60000"/>
                  <a:lumOff val="4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A6D5-4CDE-98C3-69CE473A239C}"/>
              </c:ext>
            </c:extLst>
          </c:dPt>
          <c:dPt>
            <c:idx val="3"/>
            <c:bubble3D val="0"/>
            <c:spPr>
              <a:solidFill>
                <a:schemeClr val="accent6">
                  <a:lumMod val="20000"/>
                  <a:lumOff val="8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A6D5-4CDE-98C3-69CE473A239C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QA"/>
              </a:p>
            </c:txPr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Sheet6!$F$16:$F$19</c:f>
              <c:strCache>
                <c:ptCount val="4"/>
                <c:pt idx="0">
                  <c:v>Children (&lt; 1-9 years)</c:v>
                </c:pt>
                <c:pt idx="1">
                  <c:v>Adolscence (10-17)</c:v>
                </c:pt>
                <c:pt idx="2">
                  <c:v>Adult (18-59)</c:v>
                </c:pt>
                <c:pt idx="3">
                  <c:v>Seniors  (&gt; 60 years)</c:v>
                </c:pt>
              </c:strCache>
            </c:strRef>
          </c:cat>
          <c:val>
            <c:numRef>
              <c:f>Sheet6!$H$16:$H$19</c:f>
              <c:numCache>
                <c:formatCode>0%</c:formatCode>
                <c:ptCount val="4"/>
                <c:pt idx="0">
                  <c:v>0.70967741935483875</c:v>
                </c:pt>
                <c:pt idx="1">
                  <c:v>0</c:v>
                </c:pt>
                <c:pt idx="2">
                  <c:v>0.35483870967741937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A6D5-4CDE-98C3-69CE473A239C}"/>
            </c:ext>
          </c:extLst>
        </c:ser>
        <c:dLbls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57202274715660539"/>
          <c:y val="0.40414224263633713"/>
          <c:w val="0.26131058617672792"/>
          <c:h val="0.3125021872265967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QA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QA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QA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Sheet6!$H$26</c:f>
              <c:strCache>
                <c:ptCount val="1"/>
                <c:pt idx="0">
                  <c:v>Parechovirus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explosion val="5"/>
          <c:dPt>
            <c:idx val="0"/>
            <c:bubble3D val="0"/>
            <c:spPr>
              <a:solidFill>
                <a:srgbClr val="00B0F0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615-4971-9DF4-2BEABE0FE2D4}"/>
              </c:ext>
            </c:extLst>
          </c:dPt>
          <c:dPt>
            <c:idx val="1"/>
            <c:bubble3D val="0"/>
            <c:spPr>
              <a:solidFill>
                <a:srgbClr val="66CCFF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9615-4971-9DF4-2BEABE0FE2D4}"/>
              </c:ext>
            </c:extLst>
          </c:dPt>
          <c:dPt>
            <c:idx val="2"/>
            <c:bubble3D val="0"/>
            <c:spPr>
              <a:solidFill>
                <a:srgbClr val="CCECFF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9615-4971-9DF4-2BEABE0FE2D4}"/>
              </c:ext>
            </c:extLst>
          </c:dPt>
          <c:dPt>
            <c:idx val="3"/>
            <c:bubble3D val="0"/>
            <c:spPr>
              <a:solidFill>
                <a:srgbClr val="FFFFFF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9615-4971-9DF4-2BEABE0FE2D4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QA"/>
              </a:p>
            </c:txPr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Sheet6!$F$27:$F$30</c:f>
              <c:strCache>
                <c:ptCount val="4"/>
                <c:pt idx="0">
                  <c:v>Children (&lt; 1-9 years)</c:v>
                </c:pt>
                <c:pt idx="1">
                  <c:v>Adolscence (10-17)</c:v>
                </c:pt>
                <c:pt idx="2">
                  <c:v>Adult (18-59)</c:v>
                </c:pt>
                <c:pt idx="3">
                  <c:v>Seniors  (&gt; 60 years)</c:v>
                </c:pt>
              </c:strCache>
            </c:strRef>
          </c:cat>
          <c:val>
            <c:numRef>
              <c:f>Sheet6!$H$27:$H$30</c:f>
              <c:numCache>
                <c:formatCode>0%</c:formatCode>
                <c:ptCount val="4"/>
                <c:pt idx="0">
                  <c:v>0.8666666666666667</c:v>
                </c:pt>
                <c:pt idx="1">
                  <c:v>0</c:v>
                </c:pt>
                <c:pt idx="2">
                  <c:v>0.1</c:v>
                </c:pt>
                <c:pt idx="3">
                  <c:v>3.333333333333333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9615-4971-9DF4-2BEABE0FE2D4}"/>
            </c:ext>
          </c:extLst>
        </c:ser>
        <c:dLbls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59146719160104988"/>
          <c:y val="0.39025335374744824"/>
          <c:w val="0.26131058617672792"/>
          <c:h val="0.3125021872265967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QA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QA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QA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Sheet6!$L$15</c:f>
              <c:strCache>
                <c:ptCount val="1"/>
                <c:pt idx="0">
                  <c:v>Varicella zoster virus 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dPt>
            <c:idx val="0"/>
            <c:bubble3D val="0"/>
            <c:spPr>
              <a:solidFill>
                <a:srgbClr val="FFCC66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0E73-4FBC-92A0-A68B3018F748}"/>
              </c:ext>
            </c:extLst>
          </c:dPt>
          <c:dPt>
            <c:idx val="1"/>
            <c:bubble3D val="0"/>
            <c:spPr>
              <a:solidFill>
                <a:srgbClr val="FFFFCC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0E73-4FBC-92A0-A68B3018F748}"/>
              </c:ext>
            </c:extLst>
          </c:dPt>
          <c:dPt>
            <c:idx val="2"/>
            <c:bubble3D val="0"/>
            <c:explosion val="7"/>
            <c:spPr>
              <a:solidFill>
                <a:srgbClr val="FF9933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0E73-4FBC-92A0-A68B3018F748}"/>
              </c:ext>
            </c:extLst>
          </c:dPt>
          <c:dPt>
            <c:idx val="3"/>
            <c:bubble3D val="0"/>
            <c:spPr>
              <a:solidFill>
                <a:srgbClr val="FFFF99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0E73-4FBC-92A0-A68B3018F748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QA"/>
              </a:p>
            </c:txPr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Sheet6!$J$16:$J$19</c:f>
              <c:strCache>
                <c:ptCount val="4"/>
                <c:pt idx="0">
                  <c:v>Children (&lt; 1-9 years)</c:v>
                </c:pt>
                <c:pt idx="1">
                  <c:v>Adolscence (10-17)</c:v>
                </c:pt>
                <c:pt idx="2">
                  <c:v>Adult (18-59)</c:v>
                </c:pt>
                <c:pt idx="3">
                  <c:v>Seniors  (&gt; 60 years)</c:v>
                </c:pt>
              </c:strCache>
            </c:strRef>
          </c:cat>
          <c:val>
            <c:numRef>
              <c:f>Sheet6!$L$16:$L$19</c:f>
              <c:numCache>
                <c:formatCode>0%</c:formatCode>
                <c:ptCount val="4"/>
                <c:pt idx="0">
                  <c:v>0.22857142857142856</c:v>
                </c:pt>
                <c:pt idx="1">
                  <c:v>5.7142857142857141E-2</c:v>
                </c:pt>
                <c:pt idx="2">
                  <c:v>0.51428571428571423</c:v>
                </c:pt>
                <c:pt idx="3">
                  <c:v>0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0E73-4FBC-92A0-A68B3018F748}"/>
            </c:ext>
          </c:extLst>
        </c:ser>
        <c:dLbls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59424496937882765"/>
          <c:y val="0.40414224263633713"/>
          <c:w val="0.26131058617672792"/>
          <c:h val="0.3125021872265967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QA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QA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63C62E-E6C5-4544-ACAC-5BCB55C18BCB}" type="datetimeFigureOut">
              <a:rPr lang="en-US" smtClean="0"/>
              <a:t>6/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AD870-C5D9-4D93-84C3-195C239B01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24899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63C62E-E6C5-4544-ACAC-5BCB55C18BCB}" type="datetimeFigureOut">
              <a:rPr lang="en-US" smtClean="0"/>
              <a:t>6/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AD870-C5D9-4D93-84C3-195C239B01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96135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63C62E-E6C5-4544-ACAC-5BCB55C18BCB}" type="datetimeFigureOut">
              <a:rPr lang="en-US" smtClean="0"/>
              <a:t>6/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AD870-C5D9-4D93-84C3-195C239B01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31742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63C62E-E6C5-4544-ACAC-5BCB55C18BCB}" type="datetimeFigureOut">
              <a:rPr lang="en-US" smtClean="0"/>
              <a:t>6/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AD870-C5D9-4D93-84C3-195C239B01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5906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63C62E-E6C5-4544-ACAC-5BCB55C18BCB}" type="datetimeFigureOut">
              <a:rPr lang="en-US" smtClean="0"/>
              <a:t>6/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AD870-C5D9-4D93-84C3-195C239B01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58105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63C62E-E6C5-4544-ACAC-5BCB55C18BCB}" type="datetimeFigureOut">
              <a:rPr lang="en-US" smtClean="0"/>
              <a:t>6/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AD870-C5D9-4D93-84C3-195C239B01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63575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63C62E-E6C5-4544-ACAC-5BCB55C18BCB}" type="datetimeFigureOut">
              <a:rPr lang="en-US" smtClean="0"/>
              <a:t>6/2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AD870-C5D9-4D93-84C3-195C239B01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9864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63C62E-E6C5-4544-ACAC-5BCB55C18BCB}" type="datetimeFigureOut">
              <a:rPr lang="en-US" smtClean="0"/>
              <a:t>6/2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AD870-C5D9-4D93-84C3-195C239B01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16718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63C62E-E6C5-4544-ACAC-5BCB55C18BCB}" type="datetimeFigureOut">
              <a:rPr lang="en-US" smtClean="0"/>
              <a:t>6/2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AD870-C5D9-4D93-84C3-195C239B01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1327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63C62E-E6C5-4544-ACAC-5BCB55C18BCB}" type="datetimeFigureOut">
              <a:rPr lang="en-US" smtClean="0"/>
              <a:t>6/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AD870-C5D9-4D93-84C3-195C239B01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94908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63C62E-E6C5-4544-ACAC-5BCB55C18BCB}" type="datetimeFigureOut">
              <a:rPr lang="en-US" smtClean="0"/>
              <a:t>6/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AD870-C5D9-4D93-84C3-195C239B01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01496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63C62E-E6C5-4544-ACAC-5BCB55C18BCB}" type="datetimeFigureOut">
              <a:rPr lang="en-US" smtClean="0"/>
              <a:t>6/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0AD870-C5D9-4D93-84C3-195C239B01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40670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/>
        </p:nvGraphicFramePr>
        <p:xfrm>
          <a:off x="901700" y="701675"/>
          <a:ext cx="4637088" cy="2762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5" name="Prism 7" r:id="rId3" imgW="4944303" imgH="2945700" progId="Prism7.Document">
                  <p:embed/>
                </p:oleObj>
              </mc:Choice>
              <mc:Fallback>
                <p:oleObj name="Prism 7" r:id="rId3" imgW="4944303" imgH="2945700" progId="Prism7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01700" y="701675"/>
                        <a:ext cx="4637088" cy="27622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/>
        </p:nvGraphicFramePr>
        <p:xfrm>
          <a:off x="6053138" y="701675"/>
          <a:ext cx="4713287" cy="2762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7" r:id="rId5" imgW="5026414" imgH="2945700" progId="Prism7.Document">
                  <p:embed/>
                </p:oleObj>
              </mc:Choice>
              <mc:Fallback>
                <p:oleObj name="Prism 7" r:id="rId5" imgW="5026414" imgH="2945700" progId="Prism7.Document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053138" y="701675"/>
                        <a:ext cx="4713287" cy="27622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/>
        </p:nvGraphicFramePr>
        <p:xfrm>
          <a:off x="901700" y="3633788"/>
          <a:ext cx="4637088" cy="2762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7" r:id="rId7" imgW="4944303" imgH="2945700" progId="Prism7.Document">
                  <p:embed/>
                </p:oleObj>
              </mc:Choice>
              <mc:Fallback>
                <p:oleObj name="Prism 7" r:id="rId7" imgW="4944303" imgH="2945700" progId="Prism7.Document">
                  <p:embed/>
                  <p:pic>
                    <p:nvPicPr>
                      <p:cNvPr id="6" name="Object 5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901700" y="3633788"/>
                        <a:ext cx="4637088" cy="27622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/>
        </p:nvGraphicFramePr>
        <p:xfrm>
          <a:off x="6188075" y="3633788"/>
          <a:ext cx="4711700" cy="2762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Prism 7" r:id="rId9" imgW="5026414" imgH="2945700" progId="Prism7.Document">
                  <p:embed/>
                </p:oleObj>
              </mc:Choice>
              <mc:Fallback>
                <p:oleObj name="Prism 7" r:id="rId9" imgW="5026414" imgH="2945700" progId="Prism7.Document">
                  <p:embed/>
                  <p:pic>
                    <p:nvPicPr>
                      <p:cNvPr id="7" name="Object 6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6188075" y="3633788"/>
                        <a:ext cx="4711700" cy="27622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itle 1"/>
          <p:cNvSpPr>
            <a:spLocks noGrp="1"/>
          </p:cNvSpPr>
          <p:nvPr>
            <p:ph type="title"/>
          </p:nvPr>
        </p:nvSpPr>
        <p:spPr>
          <a:xfrm>
            <a:off x="376328" y="38171"/>
            <a:ext cx="10515600" cy="1325563"/>
          </a:xfrm>
        </p:spPr>
        <p:txBody>
          <a:bodyPr>
            <a:normAutofit/>
          </a:bodyPr>
          <a:lstStyle/>
          <a:p>
            <a:r>
              <a:rPr lang="en-US" sz="1800" b="1" dirty="0"/>
              <a:t>Supplementary Data 1: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0348721B-9B2A-D248-9D38-E8E8D3035DAC}"/>
              </a:ext>
            </a:extLst>
          </p:cNvPr>
          <p:cNvSpPr/>
          <p:nvPr/>
        </p:nvSpPr>
        <p:spPr>
          <a:xfrm>
            <a:off x="310775" y="6239357"/>
            <a:ext cx="11570449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800"/>
              </a:spcAft>
            </a:pP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. figure 1.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nder distribution of the identiﬁed viral agents associated with meningitis in Qatar between 2015–2018. </a:t>
            </a:r>
          </a:p>
        </p:txBody>
      </p:sp>
    </p:spTree>
    <p:extLst>
      <p:ext uri="{BB962C8B-B14F-4D97-AF65-F5344CB8AC3E}">
        <p14:creationId xmlns:p14="http://schemas.microsoft.com/office/powerpoint/2010/main" val="7667079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/>
          <p:cNvGraphicFramePr>
            <a:graphicFrameLocks/>
          </p:cNvGraphicFramePr>
          <p:nvPr/>
        </p:nvGraphicFramePr>
        <p:xfrm>
          <a:off x="-676894" y="121722"/>
          <a:ext cx="4182094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/>
        </p:nvGraphicFramePr>
        <p:xfrm>
          <a:off x="2463140" y="121722"/>
          <a:ext cx="4253346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/>
        </p:nvGraphicFramePr>
        <p:xfrm>
          <a:off x="5482442" y="121722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/>
        </p:nvGraphicFramePr>
        <p:xfrm>
          <a:off x="-449284" y="3372592"/>
          <a:ext cx="3954484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/>
        </p:nvGraphicFramePr>
        <p:xfrm>
          <a:off x="2303813" y="3360716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/>
        </p:nvGraphicFramePr>
        <p:xfrm>
          <a:off x="8574975" y="121722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/>
        </p:nvGraphicFramePr>
        <p:xfrm>
          <a:off x="5482442" y="3360716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2" name="Chart 11"/>
          <p:cNvGraphicFramePr>
            <a:graphicFrameLocks/>
          </p:cNvGraphicFramePr>
          <p:nvPr/>
        </p:nvGraphicFramePr>
        <p:xfrm>
          <a:off x="8661071" y="3360716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13" name="Rectangle 12"/>
          <p:cNvSpPr/>
          <p:nvPr/>
        </p:nvSpPr>
        <p:spPr>
          <a:xfrm>
            <a:off x="310775" y="6239357"/>
            <a:ext cx="11570449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800"/>
              </a:spcAft>
            </a:pP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. figure 2.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revalence of circulating VM agents associated with age groups represented in pie chart. (A) Enterovirus (B) Epstein-Barr virus (C) Adenovirus (D) Cytomegalovirus (E) Herpes simplex virus type 1 (F) Herpes simplex virus type 2 (G) Parechovirus (H) Varicella zoster virus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13891" y="2495590"/>
            <a:ext cx="5937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005445" y="2495590"/>
            <a:ext cx="5937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6282046" y="2491495"/>
            <a:ext cx="5937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9167787" y="2491495"/>
            <a:ext cx="5937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0" y="5758336"/>
            <a:ext cx="5937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2911433" y="5758336"/>
            <a:ext cx="5937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6121728" y="5758336"/>
            <a:ext cx="5937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9300357" y="5802305"/>
            <a:ext cx="5937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H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577053" y="2563083"/>
            <a:ext cx="8371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N=503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3656721" y="2579733"/>
            <a:ext cx="8371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N=55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7097540" y="2587923"/>
            <a:ext cx="8371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N=50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10066923" y="2562673"/>
            <a:ext cx="8371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N=33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710597" y="5894638"/>
            <a:ext cx="8371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N=12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3710212" y="5893343"/>
            <a:ext cx="8371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N=14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049159" y="5837499"/>
            <a:ext cx="8371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N=30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10152472" y="5893342"/>
            <a:ext cx="8371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N=35</a:t>
            </a:r>
          </a:p>
        </p:txBody>
      </p:sp>
      <p:sp>
        <p:nvSpPr>
          <p:cNvPr id="29" name="Title 1"/>
          <p:cNvSpPr>
            <a:spLocks noGrp="1"/>
          </p:cNvSpPr>
          <p:nvPr>
            <p:ph type="title"/>
          </p:nvPr>
        </p:nvSpPr>
        <p:spPr>
          <a:xfrm>
            <a:off x="55422" y="-13719"/>
            <a:ext cx="10515600" cy="419029"/>
          </a:xfrm>
        </p:spPr>
        <p:txBody>
          <a:bodyPr>
            <a:normAutofit/>
          </a:bodyPr>
          <a:lstStyle/>
          <a:p>
            <a:r>
              <a:rPr lang="en-US" sz="1800" b="1" dirty="0"/>
              <a:t>Supplementary Data 2:</a:t>
            </a:r>
          </a:p>
        </p:txBody>
      </p:sp>
    </p:spTree>
    <p:extLst>
      <p:ext uri="{BB962C8B-B14F-4D97-AF65-F5344CB8AC3E}">
        <p14:creationId xmlns:p14="http://schemas.microsoft.com/office/powerpoint/2010/main" val="27531408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65</TotalTime>
  <Words>148</Words>
  <Application>Microsoft Macintosh PowerPoint</Application>
  <PresentationFormat>Widescreen</PresentationFormat>
  <Paragraphs>32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rism 7</vt:lpstr>
      <vt:lpstr>Supplementary Data 1:</vt:lpstr>
      <vt:lpstr>Supplementary Data 2: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Data 1:</dc:title>
  <dc:creator>Shilu Mathew Mathew</dc:creator>
  <cp:lastModifiedBy>Hebah Al Khatib</cp:lastModifiedBy>
  <cp:revision>3</cp:revision>
  <dcterms:created xsi:type="dcterms:W3CDTF">2021-02-03T11:25:23Z</dcterms:created>
  <dcterms:modified xsi:type="dcterms:W3CDTF">2021-06-02T09:21:21Z</dcterms:modified>
</cp:coreProperties>
</file>